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395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CC00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4954" autoAdjust="0"/>
  </p:normalViewPr>
  <p:slideViewPr>
    <p:cSldViewPr snapToGrid="0">
      <p:cViewPr varScale="1">
        <p:scale>
          <a:sx n="74" d="100"/>
          <a:sy n="74" d="100"/>
        </p:scale>
        <p:origin x="1642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44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r">
              <a:defRPr sz="1300"/>
            </a:lvl1pPr>
          </a:lstStyle>
          <a:p>
            <a:fld id="{77AA9483-565E-46D9-A842-79CD4DF778D0}" type="datetimeFigureOut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5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44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r">
              <a:defRPr sz="1300"/>
            </a:lvl1pPr>
          </a:lstStyle>
          <a:p>
            <a:fld id="{F33174FD-3531-4AD8-AF7A-64487AF244F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5468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6" y="6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146" y="6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r">
              <a:defRPr sz="1200"/>
            </a:lvl1pPr>
          </a:lstStyle>
          <a:p>
            <a:fld id="{967D371C-0BC3-47E7-8070-1D8FD1977CE7}" type="datetimeFigureOut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9988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255" tIns="44127" rIns="88255" bIns="44127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480" y="4783900"/>
            <a:ext cx="5445760" cy="3912834"/>
          </a:xfrm>
          <a:prstGeom prst="rect">
            <a:avLst/>
          </a:prstGeom>
        </p:spPr>
        <p:txBody>
          <a:bodyPr vert="horz" lIns="88255" tIns="44127" rIns="88255" bIns="4412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6" y="9441374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146" y="9441374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r">
              <a:defRPr sz="1200"/>
            </a:lvl1pPr>
          </a:lstStyle>
          <a:p>
            <a:fld id="{8087B928-A29C-4023-B70B-14035D670E3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95196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4DCA-D378-4CBA-B2EB-93C479760CB0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16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CBA4-CF1C-4256-B860-9AA9E7FB8F04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407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E0B85-B1A1-420B-8C58-5608326397E3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2792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F2AD-7792-4694-8A8D-47038094A2F6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86931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3A5AA-51B3-4289-92E7-56B34844DC67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243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D8A87-828D-49E8-A499-33D151351DDD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763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88CF2-512A-43F6-A490-B679F1114C95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28328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687B-7EE4-45EB-8EF6-70E0D13ADE99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9672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E90B6-349F-44D5-A782-8BAC83707F4E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294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95BB9-420E-4F1B-9995-3D589F84EF36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61817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4C5CE-5E4E-41FD-8680-1EA160B04991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3225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73DC1-41A9-4AF1-8DBE-785BCAA55A2A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8931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173695"/>
              </p:ext>
            </p:extLst>
          </p:nvPr>
        </p:nvGraphicFramePr>
        <p:xfrm>
          <a:off x="865240" y="1732381"/>
          <a:ext cx="6872745" cy="2216740"/>
        </p:xfrm>
        <a:graphic>
          <a:graphicData uri="http://schemas.openxmlformats.org/drawingml/2006/table">
            <a:tbl>
              <a:tblPr/>
              <a:tblGrid>
                <a:gridCol w="4521959"/>
                <a:gridCol w="906582"/>
                <a:gridCol w="1444204"/>
              </a:tblGrid>
              <a:tr h="3832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easibility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proble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umber (%)</a:t>
                      </a:r>
                      <a:endParaRPr lang="en-US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666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otal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n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mber of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patients with feasibility proble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6.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3666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Blood access</a:t>
                      </a:r>
                      <a:r>
                        <a:rPr lang="en-US" sz="14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failure</a:t>
                      </a: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3.5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3666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Venous </a:t>
                      </a: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cess difficulty</a:t>
                      </a: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</a:t>
                      </a: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.1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3666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Venous </a:t>
                      </a: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ssure elevation</a:t>
                      </a: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</a:t>
                      </a: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3.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3666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Clot</a:t>
                      </a:r>
                      <a:r>
                        <a:rPr lang="en-US" sz="14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formation</a:t>
                      </a: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n </a:t>
                      </a: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apheresis lin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</a:t>
                      </a: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.1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14820" marR="14820" marT="148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776744" y="1477506"/>
            <a:ext cx="79412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asibility problems observed in all patients who received the GMA therapy (n = 437)</a:t>
            </a:r>
          </a:p>
        </p:txBody>
      </p:sp>
      <p:sp>
        <p:nvSpPr>
          <p:cNvPr id="5" name="正方形/長方形 4"/>
          <p:cNvSpPr/>
          <p:nvPr/>
        </p:nvSpPr>
        <p:spPr>
          <a:xfrm>
            <a:off x="776744" y="3913952"/>
            <a:ext cx="59042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MA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anulocyte and monocyte adsorptive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heresi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3968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41</TotalTime>
  <Words>84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JIM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kuma Seiichiro（国馬 誠一郎）</dc:creator>
  <cp:lastModifiedBy>hosoi eiji（細井　栄治）</cp:lastModifiedBy>
  <cp:revision>1016</cp:revision>
  <cp:lastPrinted>2018-11-09T05:42:12Z</cp:lastPrinted>
  <dcterms:created xsi:type="dcterms:W3CDTF">2017-02-06T05:38:59Z</dcterms:created>
  <dcterms:modified xsi:type="dcterms:W3CDTF">2019-09-30T05:03:51Z</dcterms:modified>
</cp:coreProperties>
</file>